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A62FB-0C4E-4D38-9A52-71F90BFA21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6A73F-73B0-45A2-98B7-46CD7FE932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CEF08-3B69-43AA-858F-32A25C5443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507AA6-EA12-4A0E-900F-DCD48A772F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B27B4-0FCB-4742-AB9C-D6DAA1FF93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86BD4-4DDA-4915-B082-EA01AB0F90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891DF-1609-4C49-973E-746BA7D302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EAF50-5780-462E-AF82-D2566EDDA1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38E2F-2EE3-40A0-BD39-2DF10F9BEA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CBDDFF-4508-4042-89D8-9F05A4DD6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5B114-CBE0-49F6-8AA0-C21886CD25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C586B-C84A-4BC8-A0D5-A7195D3462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C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C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C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2224CB-F6F6-4648-8433-829C0640F89B}" type="slidenum">
              <a:rPr b="0" lang="es-C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25 Grupo"/>
          <p:cNvGrpSpPr/>
          <p:nvPr/>
        </p:nvGrpSpPr>
        <p:grpSpPr>
          <a:xfrm>
            <a:off x="468360" y="333360"/>
            <a:ext cx="7991280" cy="3213360"/>
            <a:chOff x="468360" y="333360"/>
            <a:chExt cx="7991280" cy="3213360"/>
          </a:xfrm>
        </p:grpSpPr>
        <p:sp>
          <p:nvSpPr>
            <p:cNvPr id="42" name="Freeform 25"/>
            <p:cNvSpPr/>
            <p:nvPr/>
          </p:nvSpPr>
          <p:spPr>
            <a:xfrm>
              <a:off x="468360" y="333360"/>
              <a:ext cx="7991280" cy="3213360"/>
            </a:xfrm>
            <a:custGeom>
              <a:avLst/>
              <a:gdLst>
                <a:gd name="textAreaLeft" fmla="*/ 0 w 7991280"/>
                <a:gd name="textAreaRight" fmla="*/ 7991640 w 7991280"/>
                <a:gd name="textAreaTop" fmla="*/ 0 h 3213360"/>
                <a:gd name="textAreaBottom" fmla="*/ 3213720 h 3213360"/>
              </a:gdLst>
              <a:ahLst/>
              <a:rect l="textAreaLeft" t="textAreaTop" r="textAreaRight" b="textAreaBottom"/>
              <a:pathLst>
                <a:path w="9040" h="3150">
                  <a:moveTo>
                    <a:pt x="0" y="534"/>
                  </a:moveTo>
                  <a:lnTo>
                    <a:pt x="0" y="479"/>
                  </a:lnTo>
                  <a:lnTo>
                    <a:pt x="11" y="423"/>
                  </a:lnTo>
                  <a:lnTo>
                    <a:pt x="22" y="367"/>
                  </a:lnTo>
                  <a:lnTo>
                    <a:pt x="34" y="323"/>
                  </a:lnTo>
                  <a:lnTo>
                    <a:pt x="56" y="278"/>
                  </a:lnTo>
                  <a:lnTo>
                    <a:pt x="89" y="234"/>
                  </a:lnTo>
                  <a:lnTo>
                    <a:pt x="156" y="156"/>
                  </a:lnTo>
                  <a:lnTo>
                    <a:pt x="234" y="89"/>
                  </a:lnTo>
                  <a:lnTo>
                    <a:pt x="278" y="56"/>
                  </a:lnTo>
                  <a:lnTo>
                    <a:pt x="323" y="34"/>
                  </a:lnTo>
                  <a:lnTo>
                    <a:pt x="368" y="22"/>
                  </a:lnTo>
                  <a:lnTo>
                    <a:pt x="423" y="11"/>
                  </a:lnTo>
                  <a:lnTo>
                    <a:pt x="479" y="0"/>
                  </a:lnTo>
                  <a:lnTo>
                    <a:pt x="535" y="0"/>
                  </a:lnTo>
                  <a:lnTo>
                    <a:pt x="8494" y="0"/>
                  </a:lnTo>
                  <a:lnTo>
                    <a:pt x="8550" y="0"/>
                  </a:lnTo>
                  <a:lnTo>
                    <a:pt x="8606" y="11"/>
                  </a:lnTo>
                  <a:lnTo>
                    <a:pt x="8661" y="22"/>
                  </a:lnTo>
                  <a:lnTo>
                    <a:pt x="8706" y="34"/>
                  </a:lnTo>
                  <a:lnTo>
                    <a:pt x="8751" y="56"/>
                  </a:lnTo>
                  <a:lnTo>
                    <a:pt x="8795" y="89"/>
                  </a:lnTo>
                  <a:lnTo>
                    <a:pt x="8873" y="156"/>
                  </a:lnTo>
                  <a:lnTo>
                    <a:pt x="8884" y="156"/>
                  </a:lnTo>
                  <a:lnTo>
                    <a:pt x="8940" y="234"/>
                  </a:lnTo>
                  <a:lnTo>
                    <a:pt x="8973" y="278"/>
                  </a:lnTo>
                  <a:lnTo>
                    <a:pt x="8995" y="323"/>
                  </a:lnTo>
                  <a:lnTo>
                    <a:pt x="9007" y="367"/>
                  </a:lnTo>
                  <a:lnTo>
                    <a:pt x="9029" y="423"/>
                  </a:lnTo>
                  <a:lnTo>
                    <a:pt x="9029" y="479"/>
                  </a:lnTo>
                  <a:lnTo>
                    <a:pt x="9040" y="534"/>
                  </a:lnTo>
                  <a:lnTo>
                    <a:pt x="9040" y="2605"/>
                  </a:lnTo>
                  <a:lnTo>
                    <a:pt x="9029" y="2660"/>
                  </a:lnTo>
                  <a:lnTo>
                    <a:pt x="9029" y="2716"/>
                  </a:lnTo>
                  <a:lnTo>
                    <a:pt x="9007" y="2772"/>
                  </a:lnTo>
                  <a:lnTo>
                    <a:pt x="8995" y="2816"/>
                  </a:lnTo>
                  <a:lnTo>
                    <a:pt x="8973" y="2861"/>
                  </a:lnTo>
                  <a:lnTo>
                    <a:pt x="8940" y="2905"/>
                  </a:lnTo>
                  <a:lnTo>
                    <a:pt x="8884" y="2983"/>
                  </a:lnTo>
                  <a:lnTo>
                    <a:pt x="8873" y="2994"/>
                  </a:lnTo>
                  <a:lnTo>
                    <a:pt x="8795" y="3050"/>
                  </a:lnTo>
                  <a:lnTo>
                    <a:pt x="8751" y="3083"/>
                  </a:lnTo>
                  <a:lnTo>
                    <a:pt x="8706" y="3105"/>
                  </a:lnTo>
                  <a:lnTo>
                    <a:pt x="8661" y="3117"/>
                  </a:lnTo>
                  <a:lnTo>
                    <a:pt x="8606" y="3139"/>
                  </a:lnTo>
                  <a:lnTo>
                    <a:pt x="8550" y="3139"/>
                  </a:lnTo>
                  <a:lnTo>
                    <a:pt x="8506" y="3150"/>
                  </a:lnTo>
                  <a:lnTo>
                    <a:pt x="535" y="3150"/>
                  </a:lnTo>
                  <a:lnTo>
                    <a:pt x="479" y="3139"/>
                  </a:lnTo>
                  <a:lnTo>
                    <a:pt x="423" y="3139"/>
                  </a:lnTo>
                  <a:lnTo>
                    <a:pt x="368" y="3117"/>
                  </a:lnTo>
                  <a:lnTo>
                    <a:pt x="323" y="3105"/>
                  </a:lnTo>
                  <a:lnTo>
                    <a:pt x="278" y="3083"/>
                  </a:lnTo>
                  <a:lnTo>
                    <a:pt x="234" y="3050"/>
                  </a:lnTo>
                  <a:lnTo>
                    <a:pt x="156" y="2994"/>
                  </a:lnTo>
                  <a:lnTo>
                    <a:pt x="156" y="2983"/>
                  </a:lnTo>
                  <a:lnTo>
                    <a:pt x="89" y="2905"/>
                  </a:lnTo>
                  <a:lnTo>
                    <a:pt x="56" y="2861"/>
                  </a:lnTo>
                  <a:lnTo>
                    <a:pt x="34" y="2816"/>
                  </a:lnTo>
                  <a:lnTo>
                    <a:pt x="22" y="2772"/>
                  </a:lnTo>
                  <a:lnTo>
                    <a:pt x="11" y="2716"/>
                  </a:lnTo>
                  <a:lnTo>
                    <a:pt x="0" y="2660"/>
                  </a:lnTo>
                  <a:lnTo>
                    <a:pt x="0" y="2616"/>
                  </a:lnTo>
                  <a:lnTo>
                    <a:pt x="0" y="534"/>
                  </a:lnTo>
                  <a:close/>
                  <a:moveTo>
                    <a:pt x="34" y="2605"/>
                  </a:moveTo>
                  <a:lnTo>
                    <a:pt x="34" y="2660"/>
                  </a:lnTo>
                  <a:lnTo>
                    <a:pt x="34" y="2705"/>
                  </a:lnTo>
                  <a:lnTo>
                    <a:pt x="56" y="2760"/>
                  </a:lnTo>
                  <a:lnTo>
                    <a:pt x="67" y="2805"/>
                  </a:lnTo>
                  <a:lnTo>
                    <a:pt x="89" y="2849"/>
                  </a:lnTo>
                  <a:lnTo>
                    <a:pt x="111" y="2894"/>
                  </a:lnTo>
                  <a:lnTo>
                    <a:pt x="178" y="2961"/>
                  </a:lnTo>
                  <a:lnTo>
                    <a:pt x="245" y="3028"/>
                  </a:lnTo>
                  <a:lnTo>
                    <a:pt x="290" y="3050"/>
                  </a:lnTo>
                  <a:lnTo>
                    <a:pt x="334" y="3072"/>
                  </a:lnTo>
                  <a:lnTo>
                    <a:pt x="379" y="3083"/>
                  </a:lnTo>
                  <a:lnTo>
                    <a:pt x="434" y="3105"/>
                  </a:lnTo>
                  <a:lnTo>
                    <a:pt x="479" y="3105"/>
                  </a:lnTo>
                  <a:lnTo>
                    <a:pt x="535" y="3117"/>
                  </a:lnTo>
                  <a:lnTo>
                    <a:pt x="8494" y="3117"/>
                  </a:lnTo>
                  <a:lnTo>
                    <a:pt x="8550" y="3105"/>
                  </a:lnTo>
                  <a:lnTo>
                    <a:pt x="8595" y="3105"/>
                  </a:lnTo>
                  <a:lnTo>
                    <a:pt x="8650" y="3094"/>
                  </a:lnTo>
                  <a:lnTo>
                    <a:pt x="8695" y="3072"/>
                  </a:lnTo>
                  <a:lnTo>
                    <a:pt x="8739" y="3050"/>
                  </a:lnTo>
                  <a:lnTo>
                    <a:pt x="8784" y="3028"/>
                  </a:lnTo>
                  <a:lnTo>
                    <a:pt x="8851" y="2961"/>
                  </a:lnTo>
                  <a:lnTo>
                    <a:pt x="8918" y="2894"/>
                  </a:lnTo>
                  <a:lnTo>
                    <a:pt x="8940" y="2849"/>
                  </a:lnTo>
                  <a:lnTo>
                    <a:pt x="8962" y="2805"/>
                  </a:lnTo>
                  <a:lnTo>
                    <a:pt x="8973" y="2760"/>
                  </a:lnTo>
                  <a:lnTo>
                    <a:pt x="8995" y="2716"/>
                  </a:lnTo>
                  <a:lnTo>
                    <a:pt x="8995" y="2660"/>
                  </a:lnTo>
                  <a:lnTo>
                    <a:pt x="9007" y="2605"/>
                  </a:lnTo>
                  <a:lnTo>
                    <a:pt x="9007" y="534"/>
                  </a:lnTo>
                  <a:lnTo>
                    <a:pt x="8995" y="479"/>
                  </a:lnTo>
                  <a:lnTo>
                    <a:pt x="8995" y="434"/>
                  </a:lnTo>
                  <a:lnTo>
                    <a:pt x="8984" y="379"/>
                  </a:lnTo>
                  <a:lnTo>
                    <a:pt x="8962" y="334"/>
                  </a:lnTo>
                  <a:lnTo>
                    <a:pt x="8940" y="290"/>
                  </a:lnTo>
                  <a:lnTo>
                    <a:pt x="8918" y="256"/>
                  </a:lnTo>
                  <a:lnTo>
                    <a:pt x="8851" y="178"/>
                  </a:lnTo>
                  <a:lnTo>
                    <a:pt x="8784" y="111"/>
                  </a:lnTo>
                  <a:lnTo>
                    <a:pt x="8739" y="89"/>
                  </a:lnTo>
                  <a:lnTo>
                    <a:pt x="8695" y="67"/>
                  </a:lnTo>
                  <a:lnTo>
                    <a:pt x="8650" y="56"/>
                  </a:lnTo>
                  <a:lnTo>
                    <a:pt x="8606" y="34"/>
                  </a:lnTo>
                  <a:lnTo>
                    <a:pt x="8550" y="34"/>
                  </a:lnTo>
                  <a:lnTo>
                    <a:pt x="8494" y="34"/>
                  </a:lnTo>
                  <a:lnTo>
                    <a:pt x="535" y="34"/>
                  </a:lnTo>
                  <a:lnTo>
                    <a:pt x="479" y="34"/>
                  </a:lnTo>
                  <a:lnTo>
                    <a:pt x="434" y="34"/>
                  </a:lnTo>
                  <a:lnTo>
                    <a:pt x="379" y="56"/>
                  </a:lnTo>
                  <a:lnTo>
                    <a:pt x="334" y="67"/>
                  </a:lnTo>
                  <a:lnTo>
                    <a:pt x="290" y="89"/>
                  </a:lnTo>
                  <a:lnTo>
                    <a:pt x="256" y="111"/>
                  </a:lnTo>
                  <a:lnTo>
                    <a:pt x="178" y="178"/>
                  </a:lnTo>
                  <a:lnTo>
                    <a:pt x="111" y="245"/>
                  </a:lnTo>
                  <a:lnTo>
                    <a:pt x="89" y="290"/>
                  </a:lnTo>
                  <a:lnTo>
                    <a:pt x="67" y="334"/>
                  </a:lnTo>
                  <a:lnTo>
                    <a:pt x="56" y="379"/>
                  </a:lnTo>
                  <a:lnTo>
                    <a:pt x="34" y="434"/>
                  </a:lnTo>
                  <a:lnTo>
                    <a:pt x="34" y="479"/>
                  </a:lnTo>
                  <a:lnTo>
                    <a:pt x="34" y="534"/>
                  </a:lnTo>
                  <a:lnTo>
                    <a:pt x="34" y="2605"/>
                  </a:lnTo>
                  <a:close/>
                </a:path>
              </a:pathLst>
            </a:custGeom>
            <a:solidFill>
              <a:srgbClr val="385d8a"/>
            </a:solidFill>
            <a:ln w="0">
              <a:solidFill>
                <a:srgbClr val="385d8a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24" descr=""/>
            <p:cNvPicPr/>
            <p:nvPr/>
          </p:nvPicPr>
          <p:blipFill>
            <a:blip r:embed="rId1"/>
            <a:stretch/>
          </p:blipFill>
          <p:spPr>
            <a:xfrm>
              <a:off x="6684120" y="1374120"/>
              <a:ext cx="1485720" cy="162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23" descr=""/>
            <p:cNvPicPr/>
            <p:nvPr/>
          </p:nvPicPr>
          <p:blipFill>
            <a:blip r:embed="rId2"/>
            <a:stretch/>
          </p:blipFill>
          <p:spPr>
            <a:xfrm>
              <a:off x="3876840" y="680040"/>
              <a:ext cx="2332800" cy="2407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22" descr=""/>
            <p:cNvPicPr/>
            <p:nvPr/>
          </p:nvPicPr>
          <p:blipFill>
            <a:blip r:embed="rId3"/>
            <a:stretch/>
          </p:blipFill>
          <p:spPr>
            <a:xfrm>
              <a:off x="768960" y="680040"/>
              <a:ext cx="2676600" cy="246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Rectangle 19"/>
            <p:cNvSpPr/>
            <p:nvPr/>
          </p:nvSpPr>
          <p:spPr>
            <a:xfrm>
              <a:off x="1712880" y="3161160"/>
              <a:ext cx="366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SP_1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8"/>
            <p:cNvSpPr/>
            <p:nvPr/>
          </p:nvSpPr>
          <p:spPr>
            <a:xfrm>
              <a:off x="2151360" y="316116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7"/>
            <p:cNvSpPr/>
            <p:nvPr/>
          </p:nvSpPr>
          <p:spPr>
            <a:xfrm>
              <a:off x="2219400" y="3161160"/>
              <a:ext cx="70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3"/>
            <p:cNvSpPr/>
            <p:nvPr/>
          </p:nvSpPr>
          <p:spPr>
            <a:xfrm>
              <a:off x="4555440" y="3109320"/>
              <a:ext cx="8784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Moneymaker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9"/>
            <p:cNvSpPr/>
            <p:nvPr/>
          </p:nvSpPr>
          <p:spPr>
            <a:xfrm>
              <a:off x="7245720" y="3161160"/>
              <a:ext cx="296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SP_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8"/>
            <p:cNvSpPr/>
            <p:nvPr/>
          </p:nvSpPr>
          <p:spPr>
            <a:xfrm>
              <a:off x="7604280" y="316116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7"/>
            <p:cNvSpPr/>
            <p:nvPr/>
          </p:nvSpPr>
          <p:spPr>
            <a:xfrm>
              <a:off x="7671960" y="3161160"/>
              <a:ext cx="70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6"/>
            <p:cNvSpPr/>
            <p:nvPr/>
          </p:nvSpPr>
          <p:spPr>
            <a:xfrm>
              <a:off x="853920" y="696240"/>
              <a:ext cx="799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ff0000"/>
                  </a:solidFill>
                  <a:latin typeface="Calibri"/>
                  <a:ea typeface="Arial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5"/>
            <p:cNvSpPr/>
            <p:nvPr/>
          </p:nvSpPr>
          <p:spPr>
            <a:xfrm>
              <a:off x="4048920" y="696240"/>
              <a:ext cx="8748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ff0000"/>
                  </a:solidFill>
                  <a:latin typeface="Calibri"/>
                  <a:ea typeface="Arial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4"/>
            <p:cNvSpPr/>
            <p:nvPr/>
          </p:nvSpPr>
          <p:spPr>
            <a:xfrm>
              <a:off x="6733800" y="1287000"/>
              <a:ext cx="709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ff0000"/>
                  </a:solidFill>
                  <a:latin typeface="Calibri"/>
                  <a:ea typeface="Arial"/>
                </a:rPr>
                <a:t>c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17 CuadroTexto"/>
          <p:cNvSpPr/>
          <p:nvPr/>
        </p:nvSpPr>
        <p:spPr>
          <a:xfrm>
            <a:off x="666720" y="4033800"/>
            <a:ext cx="75722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</a:t>
            </a:r>
            <a:r>
              <a:rPr b="0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asting effect FW-QTLs between ILs and MM. (a) SP_12-5 shows the effect of </a:t>
            </a:r>
            <a:r>
              <a:rPr b="0" i="1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w12.1</a:t>
            </a:r>
            <a:r>
              <a:rPr b="0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20% higher fruit weight), (b) MM (c) SP_3-3 shows the effect o of </a:t>
            </a:r>
            <a:r>
              <a:rPr b="0" i="1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w3.1</a:t>
            </a:r>
            <a:r>
              <a:rPr b="0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-27% less fruit weigh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19T20:20:32Z</dcterms:created>
  <dc:creator>USUARIO</dc:creator>
  <dc:description/>
  <dc:language>en-US</dc:language>
  <cp:lastModifiedBy>Antonio Monforte Gilabert</cp:lastModifiedBy>
  <dcterms:modified xsi:type="dcterms:W3CDTF">2016-05-19T16:08:25Z</dcterms:modified>
  <cp:revision>6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2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StageName">
    <vt:lpwstr>Author's Proof</vt:lpwstr>
  </property>
  <property fmtid="{D5CDD505-2E9C-101B-9397-08002B2CF9AE}" pid="6" name="TitleName">
    <vt:lpwstr>Presentation 2.ppt</vt:lpwstr>
  </property>
</Properties>
</file>